
<file path=[Content_Types].xml><?xml version="1.0" encoding="utf-8"?>
<Types xmlns="http://schemas.openxmlformats.org/package/2006/content-types"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703" r:id="rId2"/>
  </p:sldIdLst>
  <p:sldSz cx="6858000" cy="9144000" type="letter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97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66FF"/>
    <a:srgbClr val="FF0066"/>
    <a:srgbClr val="FFC285"/>
    <a:srgbClr val="FF9933"/>
    <a:srgbClr val="FFFFCC"/>
    <a:srgbClr val="CCECFF"/>
    <a:srgbClr val="FFCCFF"/>
    <a:srgbClr val="3AAA89"/>
    <a:srgbClr val="FF6699"/>
    <a:srgbClr val="FFC9D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275" autoAdjust="0"/>
    <p:restoredTop sz="94614" autoAdjust="0"/>
  </p:normalViewPr>
  <p:slideViewPr>
    <p:cSldViewPr snapToGrid="0" showGuides="1">
      <p:cViewPr varScale="1">
        <p:scale>
          <a:sx n="54" d="100"/>
          <a:sy n="54" d="100"/>
        </p:scale>
        <p:origin x="-2328" y="-102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498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1296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9687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4323" y="2"/>
            <a:ext cx="2949686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r">
              <a:defRPr sz="1200"/>
            </a:lvl1pPr>
          </a:lstStyle>
          <a:p>
            <a:fld id="{53C732EF-0A66-4C4E-8A5E-B12AF5D521EA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40373"/>
            <a:ext cx="2949687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4323" y="9440373"/>
            <a:ext cx="2949686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r">
              <a:defRPr sz="1200"/>
            </a:lvl1pPr>
          </a:lstStyle>
          <a:p>
            <a:fld id="{E0C27583-C035-4C07-BC3D-C1234323DC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798984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r">
              <a:defRPr sz="1200"/>
            </a:lvl1pPr>
          </a:lstStyle>
          <a:p>
            <a:fld id="{7E422628-6341-4F49-8E56-97CFD213B7F0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04" tIns="46102" rIns="92204" bIns="46102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9"/>
            <a:ext cx="5444490" cy="4472702"/>
          </a:xfrm>
          <a:prstGeom prst="rect">
            <a:avLst/>
          </a:prstGeom>
        </p:spPr>
        <p:txBody>
          <a:bodyPr vert="horz" lIns="92204" tIns="46102" rIns="92204" bIns="46102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r">
              <a:defRPr sz="1200"/>
            </a:lvl1pPr>
          </a:lstStyle>
          <a:p>
            <a:fld id="{A2642409-0AE3-43A2-89BF-E08CDC3850F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43195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600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ransition>
    <p:fade/>
  </p:transition>
  <p:hf hdr="0" ftr="0" dt="0"/>
  <p:txStyles>
    <p:titleStyle>
      <a:lvl1pPr algn="l" defTabSz="1320752" rtl="0" eaLnBrk="1" latinLnBrk="0" hangingPunct="1">
        <a:spcBef>
          <a:spcPct val="0"/>
        </a:spcBef>
        <a:buNone/>
        <a:defRPr kumimoji="1" sz="5778" kern="1200">
          <a:solidFill>
            <a:schemeClr val="accent2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495283" indent="-495283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3466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1pPr>
      <a:lvl2pPr marL="1073111" indent="-412735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889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2pPr>
      <a:lvl3pPr marL="165093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3pPr>
      <a:lvl4pPr marL="2311316" indent="-330187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4pPr>
      <a:lvl5pPr marL="2971691" indent="-330187" algn="l" defTabSz="1320752" rtl="0" eaLnBrk="1" latinLnBrk="0" hangingPunct="1">
        <a:spcBef>
          <a:spcPct val="20000"/>
        </a:spcBef>
        <a:buFont typeface="Arial" pitchFamily="34" charset="0"/>
        <a:buChar char="»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5pPr>
      <a:lvl6pPr marL="3632067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4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1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19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7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2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28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03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8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55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31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0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xmlns="" id="{7E64C9B8-5335-4326-951A-4F43F40148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820970111"/>
              </p:ext>
            </p:extLst>
          </p:nvPr>
        </p:nvGraphicFramePr>
        <p:xfrm>
          <a:off x="548680" y="276657"/>
          <a:ext cx="4032449" cy="119421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2081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6372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24790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2036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RNA-seq</a:t>
                      </a:r>
                      <a:r>
                        <a:rPr kumimoji="1" lang="en-US" altLang="ja-JP" sz="700" baseline="0"/>
                        <a:t> sample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Repliacte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Description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897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WT mESC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2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two</a:t>
                      </a:r>
                      <a:r>
                        <a:rPr kumimoji="1" lang="en-US" altLang="ja-JP" sz="700" baseline="0"/>
                        <a:t> replicates from one WT mES cell line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897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i="1" dirty="0"/>
                        <a:t>Atf7ip</a:t>
                      </a:r>
                      <a:r>
                        <a:rPr kumimoji="1" lang="en-US" altLang="ja-JP" sz="700" i="1" baseline="0" dirty="0"/>
                        <a:t> </a:t>
                      </a:r>
                      <a:r>
                        <a:rPr kumimoji="1" lang="en-US" altLang="ja-JP" sz="700" i="0" baseline="0" dirty="0"/>
                        <a:t>KO</a:t>
                      </a:r>
                      <a:endParaRPr kumimoji="1" lang="ja-JP" altLang="en-US" sz="7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2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two cell lines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897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i="1"/>
                        <a:t>Atf7ip</a:t>
                      </a:r>
                      <a:r>
                        <a:rPr kumimoji="1" lang="en-US" altLang="ja-JP" sz="700" i="1" baseline="0"/>
                        <a:t> </a:t>
                      </a:r>
                      <a:r>
                        <a:rPr kumimoji="1" lang="en-US" altLang="ja-JP" sz="700" i="0" baseline="0"/>
                        <a:t>KO + WT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4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two replicates from each cell line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897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i="1"/>
                        <a:t>Atf7ip</a:t>
                      </a:r>
                      <a:r>
                        <a:rPr kumimoji="1" lang="en-US" altLang="ja-JP" sz="700" i="0" baseline="0"/>
                        <a:t> KO + dFNIII</a:t>
                      </a:r>
                      <a:endParaRPr kumimoji="1" lang="ja-JP" altLang="en-US" sz="700" i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4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two replicates from each cell line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897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i="1" dirty="0"/>
                        <a:t>Zmym2 </a:t>
                      </a:r>
                      <a:r>
                        <a:rPr kumimoji="1" lang="en-US" altLang="ja-JP" sz="700" i="0" dirty="0"/>
                        <a:t>KO</a:t>
                      </a:r>
                      <a:endParaRPr kumimoji="1" lang="ja-JP" altLang="en-US" sz="700" i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2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dirty="0"/>
                        <a:t>two</a:t>
                      </a:r>
                      <a:r>
                        <a:rPr kumimoji="1" lang="en-US" altLang="ja-JP" sz="700" baseline="0" dirty="0"/>
                        <a:t> cell lines</a:t>
                      </a:r>
                      <a:endParaRPr kumimoji="1" lang="ja-JP" altLang="en-US" sz="7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xmlns="" id="{A92A83E2-6A6D-4FDD-9C38-9DC415C9AB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753103253"/>
              </p:ext>
            </p:extLst>
          </p:nvPr>
        </p:nvGraphicFramePr>
        <p:xfrm>
          <a:off x="548680" y="1644808"/>
          <a:ext cx="4104456" cy="594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083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7557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28804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920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ChIP-seq</a:t>
                      </a:r>
                      <a:r>
                        <a:rPr kumimoji="1" lang="en-US" altLang="ja-JP" sz="700" baseline="0"/>
                        <a:t> sample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Repliacte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dirty="0"/>
                        <a:t>Description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920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Flag-ATF7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2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two</a:t>
                      </a:r>
                      <a:r>
                        <a:rPr kumimoji="1" lang="en-US" altLang="ja-JP" sz="700" baseline="0"/>
                        <a:t> replicates from one cell line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920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i="0"/>
                        <a:t>Flag-ATF7IP</a:t>
                      </a:r>
                      <a:r>
                        <a:rPr kumimoji="1" lang="en-US" altLang="ja-JP" sz="700" i="0" baseline="0"/>
                        <a:t> dFNIII</a:t>
                      </a:r>
                      <a:endParaRPr kumimoji="1" lang="ja-JP" altLang="en-US" sz="700" i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/>
                        <a:t>2</a:t>
                      </a:r>
                      <a:endParaRPr kumimoji="1" lang="ja-JP" altLang="en-US" sz="7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dirty="0"/>
                        <a:t>two replicates from one cell line</a:t>
                      </a:r>
                      <a:endParaRPr kumimoji="1" lang="ja-JP" altLang="en-US" sz="7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C4983B81-AFC0-4875-BBAE-D998768B995C}"/>
              </a:ext>
            </a:extLst>
          </p:cNvPr>
          <p:cNvSpPr txBox="1"/>
          <p:nvPr/>
        </p:nvSpPr>
        <p:spPr>
          <a:xfrm>
            <a:off x="126980" y="132640"/>
            <a:ext cx="322524" cy="3200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80" b="1" dirty="0">
                <a:latin typeface="Helvetica" pitchFamily="2" charset="0"/>
              </a:rPr>
              <a:t>A</a:t>
            </a:r>
            <a:endParaRPr kumimoji="1" lang="ja-JP" altLang="en-US" sz="1480" b="1" dirty="0">
              <a:latin typeface="Helvetica" pitchFamily="2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xmlns="" id="{B0661F42-64D2-7A43-9AB2-72BC083E8B2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213" b="8767"/>
          <a:stretch/>
        </p:blipFill>
        <p:spPr>
          <a:xfrm>
            <a:off x="598382" y="2465012"/>
            <a:ext cx="1534804" cy="1477248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D4737522-CE28-1748-A5CA-8304149205B4}"/>
              </a:ext>
            </a:extLst>
          </p:cNvPr>
          <p:cNvSpPr txBox="1"/>
          <p:nvPr/>
        </p:nvSpPr>
        <p:spPr>
          <a:xfrm>
            <a:off x="476672" y="2391184"/>
            <a:ext cx="17782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Correlation between WT replicate</a:t>
            </a:r>
            <a:endParaRPr lang="ja-JP" altLang="en-US" sz="7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0CD86FD3-7D9A-EE40-955B-E930A44CCA51}"/>
              </a:ext>
            </a:extLst>
          </p:cNvPr>
          <p:cNvSpPr txBox="1"/>
          <p:nvPr/>
        </p:nvSpPr>
        <p:spPr>
          <a:xfrm>
            <a:off x="816537" y="3903352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WT rep1</a:t>
            </a:r>
            <a:endParaRPr lang="ja-JP" altLang="en-US" sz="7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56FA9BB9-58DD-1540-A98B-4FCACA590EB2}"/>
              </a:ext>
            </a:extLst>
          </p:cNvPr>
          <p:cNvSpPr txBox="1"/>
          <p:nvPr/>
        </p:nvSpPr>
        <p:spPr>
          <a:xfrm rot="16200000">
            <a:off x="-134404" y="3241198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/>
              <a:t>WT rep2</a:t>
            </a:r>
            <a:endParaRPr lang="ja-JP" altLang="en-US" sz="7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82086195-B905-2B4E-B466-9BE68F8F998B}"/>
              </a:ext>
            </a:extLst>
          </p:cNvPr>
          <p:cNvSpPr txBox="1"/>
          <p:nvPr/>
        </p:nvSpPr>
        <p:spPr>
          <a:xfrm>
            <a:off x="555995" y="2679216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Pearson’s r = 0.98</a:t>
            </a:r>
            <a:endParaRPr lang="ja-JP" altLang="en-US" sz="70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E1348238-B5CC-1E42-8AA6-08ACAC49E32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106" b="8598"/>
          <a:stretch/>
        </p:blipFill>
        <p:spPr>
          <a:xfrm>
            <a:off x="2479231" y="2465012"/>
            <a:ext cx="1517523" cy="1477248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5E49A440-6E35-8946-8974-74D93167661B}"/>
              </a:ext>
            </a:extLst>
          </p:cNvPr>
          <p:cNvSpPr txBox="1"/>
          <p:nvPr/>
        </p:nvSpPr>
        <p:spPr>
          <a:xfrm>
            <a:off x="2688745" y="3903352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/>
              <a:t>Atf7ip KO (TT2-5)</a:t>
            </a:r>
            <a:endParaRPr lang="ja-JP" altLang="en-US" sz="7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8E06E244-52DC-E14B-8BE6-A74E15990C5F}"/>
              </a:ext>
            </a:extLst>
          </p:cNvPr>
          <p:cNvSpPr txBox="1"/>
          <p:nvPr/>
        </p:nvSpPr>
        <p:spPr>
          <a:xfrm rot="16200000">
            <a:off x="1824869" y="3200444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Atf7ip KO (TT2-12)</a:t>
            </a:r>
            <a:endParaRPr lang="ja-JP" altLang="en-US" sz="7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C9F6CF49-9207-C547-94DC-5693AC3E2C4A}"/>
              </a:ext>
            </a:extLst>
          </p:cNvPr>
          <p:cNvSpPr txBox="1"/>
          <p:nvPr/>
        </p:nvSpPr>
        <p:spPr>
          <a:xfrm>
            <a:off x="2348880" y="2391184"/>
            <a:ext cx="17782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Correlation between </a:t>
            </a:r>
            <a:r>
              <a:rPr lang="en-US" altLang="ja-JP" sz="700" i="1" dirty="0"/>
              <a:t>Atf7ip </a:t>
            </a:r>
            <a:r>
              <a:rPr lang="en-US" altLang="ja-JP" sz="700" dirty="0"/>
              <a:t>KO clones</a:t>
            </a:r>
            <a:endParaRPr lang="ja-JP" altLang="en-US" sz="700" i="1"/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xmlns="" id="{7F2F0AE9-732A-4448-B046-7D40097F38A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107" b="7301"/>
          <a:stretch/>
        </p:blipFill>
        <p:spPr>
          <a:xfrm>
            <a:off x="4343198" y="2477907"/>
            <a:ext cx="1534004" cy="1498554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DFBBE478-A6BD-E440-908E-FBBAD409E0C4}"/>
              </a:ext>
            </a:extLst>
          </p:cNvPr>
          <p:cNvSpPr txBox="1"/>
          <p:nvPr/>
        </p:nvSpPr>
        <p:spPr>
          <a:xfrm>
            <a:off x="4560953" y="3903352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Zmym2 KO #1</a:t>
            </a:r>
            <a:endParaRPr lang="ja-JP" altLang="en-US" sz="7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37536663-891C-AE42-B80B-E096D787DC41}"/>
              </a:ext>
            </a:extLst>
          </p:cNvPr>
          <p:cNvSpPr txBox="1"/>
          <p:nvPr/>
        </p:nvSpPr>
        <p:spPr>
          <a:xfrm rot="16200000">
            <a:off x="3699861" y="3200444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Zmym2 KO #2</a:t>
            </a:r>
            <a:endParaRPr lang="ja-JP" altLang="en-US" sz="7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4710FC8A-120A-7549-B5E9-AFE70BB11842}"/>
              </a:ext>
            </a:extLst>
          </p:cNvPr>
          <p:cNvSpPr txBox="1"/>
          <p:nvPr/>
        </p:nvSpPr>
        <p:spPr>
          <a:xfrm>
            <a:off x="4221088" y="2391184"/>
            <a:ext cx="17782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/>
              <a:t>Correlation between </a:t>
            </a:r>
            <a:r>
              <a:rPr lang="en-US" altLang="ja-JP" sz="700" i="1"/>
              <a:t>Zmym2 </a:t>
            </a:r>
            <a:r>
              <a:rPr lang="en-US" altLang="ja-JP" sz="700"/>
              <a:t>KO clones</a:t>
            </a:r>
            <a:endParaRPr lang="ja-JP" altLang="en-US" sz="700" i="1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BE9F231E-D1F4-8C41-813C-B90379221082}"/>
              </a:ext>
            </a:extLst>
          </p:cNvPr>
          <p:cNvSpPr txBox="1"/>
          <p:nvPr/>
        </p:nvSpPr>
        <p:spPr>
          <a:xfrm>
            <a:off x="2420888" y="2679216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Pearson’s r = 0.99</a:t>
            </a:r>
            <a:endParaRPr lang="ja-JP" altLang="en-US" sz="7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822857EE-E564-E544-A8B1-6E43F929EC18}"/>
              </a:ext>
            </a:extLst>
          </p:cNvPr>
          <p:cNvSpPr txBox="1"/>
          <p:nvPr/>
        </p:nvSpPr>
        <p:spPr>
          <a:xfrm>
            <a:off x="4316688" y="2679216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/>
              <a:t>Pearson’s r = 0.99</a:t>
            </a:r>
            <a:endParaRPr lang="ja-JP" altLang="en-US" sz="700"/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xmlns="" id="{FAC590AE-B981-9745-BA0A-94C0A6BFBDA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106" b="8363"/>
          <a:stretch/>
        </p:blipFill>
        <p:spPr>
          <a:xfrm>
            <a:off x="616725" y="4249992"/>
            <a:ext cx="1498118" cy="1462112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344049CF-BCA6-D14C-92BD-4233CD391BDE}"/>
              </a:ext>
            </a:extLst>
          </p:cNvPr>
          <p:cNvSpPr txBox="1"/>
          <p:nvPr/>
        </p:nvSpPr>
        <p:spPr>
          <a:xfrm>
            <a:off x="816537" y="5690151"/>
            <a:ext cx="1098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/>
              <a:t>Atf7ip KO (TT2-5) + </a:t>
            </a:r>
          </a:p>
          <a:p>
            <a:pPr algn="ctr"/>
            <a:r>
              <a:rPr lang="en-US" altLang="ja-JP" sz="700"/>
              <a:t>WT ATF7IP</a:t>
            </a:r>
            <a:endParaRPr lang="ja-JP" altLang="en-US" sz="7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62262ACD-8028-D844-B6BB-70D5E46355FF}"/>
              </a:ext>
            </a:extLst>
          </p:cNvPr>
          <p:cNvSpPr txBox="1"/>
          <p:nvPr/>
        </p:nvSpPr>
        <p:spPr>
          <a:xfrm rot="16200000">
            <a:off x="-134404" y="4928408"/>
            <a:ext cx="1098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Atf7ip KO (TT2-12) + </a:t>
            </a:r>
          </a:p>
          <a:p>
            <a:pPr algn="ctr"/>
            <a:r>
              <a:rPr lang="en-US" altLang="ja-JP" sz="700" dirty="0"/>
              <a:t>WT ATF7IP</a:t>
            </a:r>
            <a:endParaRPr lang="ja-JP" altLang="en-US" sz="7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ACA2453C-ED9A-EE4E-8BD2-0986007B5512}"/>
              </a:ext>
            </a:extLst>
          </p:cNvPr>
          <p:cNvSpPr txBox="1"/>
          <p:nvPr/>
        </p:nvSpPr>
        <p:spPr>
          <a:xfrm>
            <a:off x="620688" y="4479416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Pearson’s r = 0.99</a:t>
            </a:r>
            <a:endParaRPr lang="ja-JP" altLang="en-US" sz="7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2D6038FE-2FE5-FA4D-9CC3-81A3288F5246}"/>
              </a:ext>
            </a:extLst>
          </p:cNvPr>
          <p:cNvSpPr txBox="1"/>
          <p:nvPr/>
        </p:nvSpPr>
        <p:spPr>
          <a:xfrm>
            <a:off x="476672" y="4191384"/>
            <a:ext cx="17782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Correlation between WT ATF7IP rescue </a:t>
            </a:r>
            <a:endParaRPr lang="ja-JP" altLang="en-US" sz="700" i="1"/>
          </a:p>
        </p:txBody>
      </p:sp>
      <p:pic>
        <p:nvPicPr>
          <p:cNvPr id="27" name="図 26">
            <a:extLst>
              <a:ext uri="{FF2B5EF4-FFF2-40B4-BE49-F238E27FC236}">
                <a16:creationId xmlns:a16="http://schemas.microsoft.com/office/drawing/2014/main" xmlns="" id="{A912CB89-62FE-6F40-8166-57A4BEBE015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321" b="9251"/>
          <a:stretch/>
        </p:blipFill>
        <p:spPr>
          <a:xfrm>
            <a:off x="2497973" y="4249991"/>
            <a:ext cx="1492614" cy="144594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B53211A7-AAFB-F049-B558-C31B55B258DD}"/>
              </a:ext>
            </a:extLst>
          </p:cNvPr>
          <p:cNvSpPr txBox="1"/>
          <p:nvPr/>
        </p:nvSpPr>
        <p:spPr>
          <a:xfrm>
            <a:off x="2695033" y="5690151"/>
            <a:ext cx="1098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/>
              <a:t>Atf7ip KO (TT2-5) + </a:t>
            </a:r>
          </a:p>
          <a:p>
            <a:pPr algn="ctr"/>
            <a:r>
              <a:rPr lang="en-US" altLang="ja-JP" sz="700"/>
              <a:t>dFNIII ATF7IP</a:t>
            </a:r>
            <a:endParaRPr lang="ja-JP" altLang="en-US" sz="7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97C723D6-4547-8F4D-BD4B-3310C81C9F51}"/>
              </a:ext>
            </a:extLst>
          </p:cNvPr>
          <p:cNvSpPr txBox="1"/>
          <p:nvPr/>
        </p:nvSpPr>
        <p:spPr>
          <a:xfrm rot="16200000">
            <a:off x="1821284" y="4828356"/>
            <a:ext cx="1098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/>
              <a:t>Atf7ip KO (TT2-12) + </a:t>
            </a:r>
          </a:p>
          <a:p>
            <a:pPr algn="ctr"/>
            <a:r>
              <a:rPr lang="en-US" altLang="ja-JP" sz="700"/>
              <a:t>dFNIII ATF7IP</a:t>
            </a:r>
            <a:endParaRPr lang="ja-JP" altLang="en-US" sz="7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5B7EB309-AA17-D94D-9DE3-FAB3A97C9998}"/>
              </a:ext>
            </a:extLst>
          </p:cNvPr>
          <p:cNvSpPr txBox="1"/>
          <p:nvPr/>
        </p:nvSpPr>
        <p:spPr>
          <a:xfrm>
            <a:off x="2276872" y="4191807"/>
            <a:ext cx="19348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Correlation between </a:t>
            </a:r>
            <a:r>
              <a:rPr lang="en-US" altLang="ja-JP" sz="700" dirty="0" err="1"/>
              <a:t>dFNIII</a:t>
            </a:r>
            <a:r>
              <a:rPr lang="en-US" altLang="ja-JP" sz="700" dirty="0"/>
              <a:t> ATF7IP rescue </a:t>
            </a:r>
            <a:endParaRPr lang="ja-JP" altLang="en-US" sz="700" i="1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ED48C9DE-5D56-254B-89AA-228BC8ABEB92}"/>
              </a:ext>
            </a:extLst>
          </p:cNvPr>
          <p:cNvSpPr txBox="1"/>
          <p:nvPr/>
        </p:nvSpPr>
        <p:spPr>
          <a:xfrm>
            <a:off x="2445600" y="4471794"/>
            <a:ext cx="10984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/>
              <a:t>Pearson’s r = 0.99</a:t>
            </a:r>
            <a:endParaRPr lang="ja-JP" altLang="en-US" sz="7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DE548BFF-7DAB-3742-9CA2-FA4E5B68B4BF}"/>
              </a:ext>
            </a:extLst>
          </p:cNvPr>
          <p:cNvSpPr txBox="1"/>
          <p:nvPr/>
        </p:nvSpPr>
        <p:spPr>
          <a:xfrm>
            <a:off x="126980" y="2247168"/>
            <a:ext cx="322524" cy="3200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80" b="1" dirty="0">
                <a:latin typeface="Helvetica" pitchFamily="2" charset="0"/>
              </a:rPr>
              <a:t>B</a:t>
            </a:r>
            <a:endParaRPr kumimoji="1" lang="ja-JP" altLang="en-US" sz="1480" b="1" dirty="0"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6D05FF7B-BE2A-2845-8C45-F74AEAEE21B2}"/>
              </a:ext>
            </a:extLst>
          </p:cNvPr>
          <p:cNvSpPr txBox="1"/>
          <p:nvPr/>
        </p:nvSpPr>
        <p:spPr>
          <a:xfrm>
            <a:off x="836712" y="6201692"/>
            <a:ext cx="18573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dirty="0"/>
              <a:t>Log2 (RPM+1)</a:t>
            </a:r>
            <a:endParaRPr lang="ja-JP" altLang="en-US" sz="788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63B1B060-5408-194A-A65A-F3AB33BF39A5}"/>
              </a:ext>
            </a:extLst>
          </p:cNvPr>
          <p:cNvSpPr txBox="1"/>
          <p:nvPr/>
        </p:nvSpPr>
        <p:spPr>
          <a:xfrm>
            <a:off x="836712" y="6033374"/>
            <a:ext cx="1857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/>
              <a:t>Gene expression</a:t>
            </a:r>
            <a:endParaRPr lang="ja-JP" altLang="en-US" sz="900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xmlns="" id="{913C1E6A-E2C7-A449-83EC-080A4DCA8349}"/>
              </a:ext>
            </a:extLst>
          </p:cNvPr>
          <p:cNvGrpSpPr/>
          <p:nvPr/>
        </p:nvGrpSpPr>
        <p:grpSpPr>
          <a:xfrm>
            <a:off x="404664" y="6385912"/>
            <a:ext cx="2780928" cy="2420888"/>
            <a:chOff x="3933056" y="6588224"/>
            <a:chExt cx="2780928" cy="2420888"/>
          </a:xfrm>
        </p:grpSpPr>
        <p:pic>
          <p:nvPicPr>
            <p:cNvPr id="36" name="図 35">
              <a:extLst>
                <a:ext uri="{FF2B5EF4-FFF2-40B4-BE49-F238E27FC236}">
                  <a16:creationId xmlns:a16="http://schemas.microsoft.com/office/drawing/2014/main" xmlns="" id="{D2ACC55C-4626-C94D-98C8-D1EA21CDE0E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293096" y="6588224"/>
              <a:ext cx="2420888" cy="2420888"/>
            </a:xfrm>
            <a:prstGeom prst="rect">
              <a:avLst/>
            </a:prstGeom>
          </p:spPr>
        </p:pic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xmlns="" id="{B4292345-E95E-A746-81CF-0611860DEFA6}"/>
                </a:ext>
              </a:extLst>
            </p:cNvPr>
            <p:cNvSpPr txBox="1"/>
            <p:nvPr/>
          </p:nvSpPr>
          <p:spPr>
            <a:xfrm>
              <a:off x="4941168" y="7308304"/>
              <a:ext cx="9644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i="1">
                  <a:solidFill>
                    <a:srgbClr val="F8766D"/>
                  </a:solidFill>
                </a:rPr>
                <a:t>Atf7ip </a:t>
              </a:r>
              <a:r>
                <a:rPr lang="en-US" altLang="ja-JP" sz="700">
                  <a:solidFill>
                    <a:srgbClr val="F8766D"/>
                  </a:solidFill>
                </a:rPr>
                <a:t>KO (TT2-5)</a:t>
              </a:r>
              <a:endParaRPr lang="ja-JP" altLang="en-US" sz="700" i="1">
                <a:solidFill>
                  <a:srgbClr val="F8766D"/>
                </a:solidFill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xmlns="" id="{202445A0-5EE8-794C-B210-D7823BE95870}"/>
                </a:ext>
              </a:extLst>
            </p:cNvPr>
            <p:cNvSpPr txBox="1"/>
            <p:nvPr/>
          </p:nvSpPr>
          <p:spPr>
            <a:xfrm>
              <a:off x="3933056" y="8100392"/>
              <a:ext cx="102512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i="1" dirty="0">
                  <a:solidFill>
                    <a:srgbClr val="F8766D"/>
                  </a:solidFill>
                </a:rPr>
                <a:t>Atf7ip </a:t>
              </a:r>
              <a:r>
                <a:rPr lang="en-US" altLang="ja-JP" sz="700" dirty="0">
                  <a:solidFill>
                    <a:srgbClr val="F8766D"/>
                  </a:solidFill>
                </a:rPr>
                <a:t>KO (TT2-12)</a:t>
              </a:r>
              <a:endParaRPr lang="ja-JP" altLang="en-US" sz="700" i="1">
                <a:solidFill>
                  <a:srgbClr val="F8766D"/>
                </a:solidFill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xmlns="" id="{BD0FEDD4-D08A-E04F-A5AB-2CF72D48892C}"/>
                </a:ext>
              </a:extLst>
            </p:cNvPr>
            <p:cNvSpPr txBox="1"/>
            <p:nvPr/>
          </p:nvSpPr>
          <p:spPr>
            <a:xfrm>
              <a:off x="4293096" y="8604448"/>
              <a:ext cx="123113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 err="1">
                  <a:solidFill>
                    <a:srgbClr val="A3A500"/>
                  </a:solidFill>
                </a:rPr>
                <a:t>dFNIII</a:t>
              </a:r>
              <a:r>
                <a:rPr lang="en-US" altLang="ja-JP" sz="700" dirty="0">
                  <a:solidFill>
                    <a:srgbClr val="A3A500"/>
                  </a:solidFill>
                </a:rPr>
                <a:t> rescue (TT2-12)</a:t>
              </a:r>
              <a:endParaRPr lang="ja-JP" altLang="en-US" sz="700" i="1">
                <a:solidFill>
                  <a:srgbClr val="A3A500"/>
                </a:solidFill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xmlns="" id="{358F5EE0-8DB8-3C4D-9218-667B2AAD58D7}"/>
                </a:ext>
              </a:extLst>
            </p:cNvPr>
            <p:cNvSpPr txBox="1"/>
            <p:nvPr/>
          </p:nvSpPr>
          <p:spPr>
            <a:xfrm>
              <a:off x="4941168" y="8100392"/>
              <a:ext cx="11195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 err="1">
                  <a:solidFill>
                    <a:srgbClr val="A3A500"/>
                  </a:solidFill>
                </a:rPr>
                <a:t>dFNIII</a:t>
              </a:r>
              <a:r>
                <a:rPr lang="en-US" altLang="ja-JP" sz="700" dirty="0">
                  <a:solidFill>
                    <a:srgbClr val="A3A500"/>
                  </a:solidFill>
                </a:rPr>
                <a:t> rescue (TT2-5)</a:t>
              </a:r>
              <a:endParaRPr lang="ja-JP" altLang="en-US" sz="700" i="1">
                <a:solidFill>
                  <a:srgbClr val="A3A500"/>
                </a:solidFill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6FAC14BE-26EB-B741-9FDD-663139A584F3}"/>
                </a:ext>
              </a:extLst>
            </p:cNvPr>
            <p:cNvSpPr txBox="1"/>
            <p:nvPr/>
          </p:nvSpPr>
          <p:spPr>
            <a:xfrm>
              <a:off x="5229200" y="8460432"/>
              <a:ext cx="100811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solidFill>
                    <a:srgbClr val="00BF7D"/>
                  </a:solidFill>
                </a:rPr>
                <a:t>WT rescue (TT2-12)</a:t>
              </a:r>
              <a:endParaRPr lang="ja-JP" altLang="en-US" sz="700" i="1">
                <a:solidFill>
                  <a:srgbClr val="00BF7D"/>
                </a:solidFill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01BFBC92-6C9A-B946-96EB-9314D02CFBEC}"/>
                </a:ext>
              </a:extLst>
            </p:cNvPr>
            <p:cNvSpPr txBox="1"/>
            <p:nvPr/>
          </p:nvSpPr>
          <p:spPr>
            <a:xfrm>
              <a:off x="5301208" y="7524328"/>
              <a:ext cx="9877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solidFill>
                    <a:srgbClr val="00BF7D"/>
                  </a:solidFill>
                </a:rPr>
                <a:t>WT rescue (TT2-5)</a:t>
              </a:r>
              <a:endParaRPr lang="ja-JP" altLang="en-US" sz="700" i="1">
                <a:solidFill>
                  <a:srgbClr val="00BF7D"/>
                </a:solidFill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xmlns="" id="{A528E76A-D249-DF42-B871-70D326A2D7D1}"/>
                </a:ext>
              </a:extLst>
            </p:cNvPr>
            <p:cNvSpPr txBox="1"/>
            <p:nvPr/>
          </p:nvSpPr>
          <p:spPr>
            <a:xfrm>
              <a:off x="4221088" y="7380312"/>
              <a:ext cx="8072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i="1" dirty="0">
                  <a:solidFill>
                    <a:srgbClr val="E76BF3"/>
                  </a:solidFill>
                </a:rPr>
                <a:t>Zmym2 </a:t>
              </a:r>
              <a:r>
                <a:rPr lang="en-US" altLang="ja-JP" sz="700" dirty="0">
                  <a:solidFill>
                    <a:srgbClr val="E76BF3"/>
                  </a:solidFill>
                </a:rPr>
                <a:t>KO</a:t>
              </a:r>
              <a:endParaRPr lang="ja-JP" altLang="en-US" sz="700" i="1">
                <a:solidFill>
                  <a:srgbClr val="E76BF3"/>
                </a:solidFill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E6862DD0-B853-9746-BC82-ED4AF79EBD22}"/>
                </a:ext>
              </a:extLst>
            </p:cNvPr>
            <p:cNvSpPr txBox="1"/>
            <p:nvPr/>
          </p:nvSpPr>
          <p:spPr>
            <a:xfrm>
              <a:off x="5013176" y="6732240"/>
              <a:ext cx="4054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solidFill>
                    <a:srgbClr val="00B0F6"/>
                  </a:solidFill>
                </a:rPr>
                <a:t>WT</a:t>
              </a:r>
              <a:endParaRPr lang="ja-JP" altLang="en-US" sz="700">
                <a:solidFill>
                  <a:srgbClr val="00B0F6"/>
                </a:solidFill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xmlns="" id="{C682A5ED-933B-A048-A1F0-F87775C41A63}"/>
                </a:ext>
              </a:extLst>
            </p:cNvPr>
            <p:cNvSpPr txBox="1"/>
            <p:nvPr/>
          </p:nvSpPr>
          <p:spPr>
            <a:xfrm>
              <a:off x="4797152" y="7740352"/>
              <a:ext cx="3548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>
                  <a:solidFill>
                    <a:srgbClr val="00B0F6"/>
                  </a:solidFill>
                </a:rPr>
                <a:t>WT</a:t>
              </a:r>
              <a:endParaRPr lang="ja-JP" altLang="en-US" sz="700">
                <a:solidFill>
                  <a:srgbClr val="00B0F6"/>
                </a:solidFill>
              </a:endParaRPr>
            </a:p>
          </p:txBody>
        </p: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60F23714-5065-574A-B928-B1C0FB50BD77}"/>
              </a:ext>
            </a:extLst>
          </p:cNvPr>
          <p:cNvSpPr txBox="1"/>
          <p:nvPr/>
        </p:nvSpPr>
        <p:spPr>
          <a:xfrm>
            <a:off x="126980" y="5939488"/>
            <a:ext cx="322524" cy="3200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80" b="1" dirty="0">
                <a:latin typeface="Helvetica" pitchFamily="2" charset="0"/>
              </a:rPr>
              <a:t>C</a:t>
            </a:r>
            <a:endParaRPr kumimoji="1" lang="ja-JP" altLang="en-US" sz="1480" b="1" dirty="0">
              <a:latin typeface="Helvetica" pitchFamily="2" charset="0"/>
            </a:endParaRPr>
          </a:p>
        </p:txBody>
      </p:sp>
      <p:sp>
        <p:nvSpPr>
          <p:cNvPr id="47" name="Text Box 49">
            <a:extLst>
              <a:ext uri="{FF2B5EF4-FFF2-40B4-BE49-F238E27FC236}">
                <a16:creationId xmlns:a16="http://schemas.microsoft.com/office/drawing/2014/main" xmlns="" id="{873F4EC3-130A-6E4C-BDCC-CB941E9596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769" y="8832695"/>
            <a:ext cx="6330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algn="ctr" eaLnBrk="1" hangingPunct="1"/>
            <a:r>
              <a:rPr lang="en-US" altLang="ja-JP" sz="1200" dirty="0">
                <a:latin typeface="Helvetica" charset="0"/>
                <a:cs typeface="Helvetica" charset="0"/>
              </a:rPr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xmlns="" val="4197678353"/>
      </p:ext>
    </p:extLst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power point テーマ1">
  <a:themeElements>
    <a:clrScheme name="ビジネス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ユーザー定義 2">
      <a:majorFont>
        <a:latin typeface="Arial"/>
        <a:ea typeface="游ゴシック"/>
        <a:cs typeface=""/>
      </a:majorFont>
      <a:minorFont>
        <a:latin typeface="Arial"/>
        <a:ea typeface="游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868</TotalTime>
  <Words>213</Words>
  <Application>Microsoft Office PowerPoint</Application>
  <PresentationFormat>Letter Paper (8.5x11 in)</PresentationFormat>
  <Paragraphs>6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ower point テーマ1</vt:lpstr>
      <vt:lpstr>Slide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t-take</dc:creator>
  <cp:lastModifiedBy>0011692</cp:lastModifiedBy>
  <cp:revision>9236</cp:revision>
  <cp:lastPrinted>2018-07-03T02:09:31Z</cp:lastPrinted>
  <dcterms:created xsi:type="dcterms:W3CDTF">2013-07-30T05:01:19Z</dcterms:created>
  <dcterms:modified xsi:type="dcterms:W3CDTF">2020-11-16T09:43:09Z</dcterms:modified>
</cp:coreProperties>
</file>